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288588" cy="6858000"/>
  <p:notesSz cx="9867900" cy="67357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867600" cy="6735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59080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3024000" y="523440"/>
            <a:ext cx="3817800" cy="25448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59080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EB8CAD-F284-4E9B-9063-250CB6A3C617}" type="slidenum">
              <a: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sldImg"/>
          </p:nvPr>
        </p:nvSpPr>
        <p:spPr>
          <a:xfrm>
            <a:off x="3024360" y="523800"/>
            <a:ext cx="3817800" cy="2544840"/>
          </a:xfrm>
          <a:prstGeom prst="rect">
            <a:avLst/>
          </a:prstGeom>
          <a:ln w="0">
            <a:noFill/>
          </a:ln>
        </p:spPr>
      </p:sp>
      <p:sp>
        <p:nvSpPr>
          <p:cNvPr id="64" name="PlaceHolder 2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スライド番号プレースホルダー 3"/>
          <p:cNvSpPr/>
          <p:nvPr/>
        </p:nvSpPr>
        <p:spPr>
          <a:xfrm>
            <a:off x="55911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F0EF4C-EBB2-4C54-BFAE-45BD09A34E56}" type="slidenum">
              <a:rPr b="1" lang="en-US" sz="1200" spc="-1" strike="noStrike">
                <a:solidFill>
                  <a:srgbClr val="ffffff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F6A8D8-D063-4D1D-BA03-761CE310D2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F26D38-4C7C-431C-BB0C-5C6FA90B98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7BCA7-A9B0-4011-8E57-CDB9518DC4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72744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8376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7112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72744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8376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714058-B641-49FD-8A50-6194E0B0A2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34F710-65BC-45EE-A997-EFEDB17A43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11E562-76FC-4E4F-A955-91C55F82AF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A3F21-8159-4C27-AAF1-BAAE8561F2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B77466-9237-4C62-B6C7-33773235F7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71120" y="609120"/>
            <a:ext cx="874404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B9F72-2B31-4909-8352-0E7E2E712F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A1DAC-30CA-4134-A327-8753646B2B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135EE-6883-430E-BCF0-5511DE94DA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367D7B-8DED-4D72-834B-770D7F0430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7112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514320" y="6248520"/>
            <a:ext cx="32576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37208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  <a:ea typeface="Osak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CFFB44-B934-4D8F-9FA7-1F1F1BBA8295}" type="slidenum">
              <a:rPr b="0" lang="en-US" sz="1400" spc="-1" strike="noStrike">
                <a:solidFill>
                  <a:srgbClr val="ffffff"/>
                </a:solidFill>
                <a:latin typeface="Times New Roman"/>
                <a:ea typeface="Osaka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1"/>
          <p:cNvGrpSpPr/>
          <p:nvPr/>
        </p:nvGrpSpPr>
        <p:grpSpPr>
          <a:xfrm>
            <a:off x="-30240" y="231840"/>
            <a:ext cx="10329840" cy="6044400"/>
            <a:chOff x="-30240" y="231840"/>
            <a:chExt cx="10329840" cy="6044400"/>
          </a:xfrm>
        </p:grpSpPr>
        <p:sp>
          <p:nvSpPr>
            <p:cNvPr id="49" name="Text Box 25"/>
            <p:cNvSpPr/>
            <p:nvPr/>
          </p:nvSpPr>
          <p:spPr>
            <a:xfrm>
              <a:off x="47520" y="2158920"/>
              <a:ext cx="4191120" cy="411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o. pts (</a:t>
              </a:r>
              <a:r>
                <a:rPr b="0" lang="ja-JP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％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Site: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　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Abdominopelvic lymph node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Lung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Bone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Liver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Muscle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Rectum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Ureter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Remnant urethra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0" name="Text Box 26"/>
            <p:cNvSpPr/>
            <p:nvPr/>
          </p:nvSpPr>
          <p:spPr>
            <a:xfrm>
              <a:off x="4114800" y="2165400"/>
              <a:ext cx="1558800" cy="375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0 (39.2</a:t>
              </a:r>
              <a:r>
                <a:rPr b="0" lang="ja-JP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）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1 (21.6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8 (15.7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7 (13.7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7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2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2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2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2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1" name="Text Box 27"/>
            <p:cNvSpPr/>
            <p:nvPr/>
          </p:nvSpPr>
          <p:spPr>
            <a:xfrm>
              <a:off x="1396440" y="258840"/>
              <a:ext cx="8862840" cy="703800"/>
            </a:xfrm>
            <a:prstGeom prst="rect">
              <a:avLst/>
            </a:prstGeom>
            <a:noFill/>
            <a:ln w="0">
              <a:noFill/>
            </a:ln>
            <a:effectLst>
              <a:outerShdw dist="17819" dir="2700000" blurRad="0" rotWithShape="0">
                <a:srgbClr val="00003d">
                  <a:alpha val="7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Recurrence rates according to the site in patients with postoperative recurrence 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2" name="Line 28"/>
            <p:cNvSpPr/>
            <p:nvPr/>
          </p:nvSpPr>
          <p:spPr>
            <a:xfrm>
              <a:off x="0" y="6130800"/>
              <a:ext cx="10287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3" name="Line 33"/>
            <p:cNvSpPr/>
            <p:nvPr/>
          </p:nvSpPr>
          <p:spPr>
            <a:xfrm>
              <a:off x="-30240" y="779400"/>
              <a:ext cx="10287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4" name="Line 34"/>
            <p:cNvSpPr/>
            <p:nvPr/>
          </p:nvSpPr>
          <p:spPr>
            <a:xfrm>
              <a:off x="12600" y="1952640"/>
              <a:ext cx="10287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5" name="Line 40"/>
            <p:cNvSpPr/>
            <p:nvPr/>
          </p:nvSpPr>
          <p:spPr>
            <a:xfrm>
              <a:off x="5543640" y="1390680"/>
              <a:ext cx="47131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6" name="Rectangle 46"/>
            <p:cNvSpPr/>
            <p:nvPr/>
          </p:nvSpPr>
          <p:spPr>
            <a:xfrm>
              <a:off x="4114800" y="981000"/>
              <a:ext cx="1371600" cy="825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Total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(n = 51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7" name="Rectangle 48"/>
            <p:cNvSpPr/>
            <p:nvPr/>
          </p:nvSpPr>
          <p:spPr>
            <a:xfrm>
              <a:off x="7194600" y="853920"/>
              <a:ext cx="163008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Diversion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8" name="Rectangle 49"/>
            <p:cNvSpPr/>
            <p:nvPr/>
          </p:nvSpPr>
          <p:spPr>
            <a:xfrm>
              <a:off x="6132240" y="1436760"/>
              <a:ext cx="160704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IC (n = 25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9" name="Rectangle 55"/>
            <p:cNvSpPr/>
            <p:nvPr/>
          </p:nvSpPr>
          <p:spPr>
            <a:xfrm>
              <a:off x="36000" y="231840"/>
              <a:ext cx="1462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Table S5.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0" name="Text Box 56"/>
            <p:cNvSpPr/>
            <p:nvPr/>
          </p:nvSpPr>
          <p:spPr>
            <a:xfrm>
              <a:off x="6170400" y="2170080"/>
              <a:ext cx="1695240" cy="375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2 (48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7 (28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16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16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 (8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4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4.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1" name="Rectangle 49"/>
            <p:cNvSpPr/>
            <p:nvPr/>
          </p:nvSpPr>
          <p:spPr>
            <a:xfrm>
              <a:off x="8038440" y="1436760"/>
              <a:ext cx="1741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B (n = 26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2" name="Text Box 56"/>
            <p:cNvSpPr/>
            <p:nvPr/>
          </p:nvSpPr>
          <p:spPr>
            <a:xfrm>
              <a:off x="8086680" y="2170080"/>
              <a:ext cx="1971720" cy="3751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8 (30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15.4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 (15.4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3 (11.5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2 (7.7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 (0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3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 (3.8)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0-05-10T06:54:23Z</dcterms:created>
  <dc:creator>pal</dc:creator>
  <dc:description/>
  <dc:language>en-US</dc:language>
  <cp:lastModifiedBy>NOZOMI HAYAKAWA</cp:lastModifiedBy>
  <cp:lastPrinted>2015-01-22T06:15:28Z</cp:lastPrinted>
  <dcterms:modified xsi:type="dcterms:W3CDTF">2015-08-05T00:21:16Z</dcterms:modified>
  <cp:revision>937</cp:revision>
  <dc:subject/>
  <dc:title>1501043</dc:title>
</cp:coreProperties>
</file>